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png" ContentType="image/png"/>
  <Override PartName="/ppt/media/image4.png" ContentType="image/png"/>
  <Override PartName="/ppt/media/image5.png" ContentType="image/png"/>
  <Override PartName="/ppt/media/image6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15389225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3BE824-3E2A-45CF-8986-74F2C042E41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615960"/>
            <a:ext cx="6172200" cy="256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3590640"/>
            <a:ext cx="6172200" cy="48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8894880"/>
            <a:ext cx="6172200" cy="48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B0C8C1-7C29-459E-8A7A-040578EB57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615960"/>
            <a:ext cx="6172200" cy="256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3590640"/>
            <a:ext cx="3011760" cy="48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3590640"/>
            <a:ext cx="3011760" cy="48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8894880"/>
            <a:ext cx="3011760" cy="48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8894880"/>
            <a:ext cx="3011760" cy="48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DB1A73-A806-459D-A887-855310FC6CE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615960"/>
            <a:ext cx="6172200" cy="256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3590640"/>
            <a:ext cx="1987200" cy="48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3590640"/>
            <a:ext cx="1987200" cy="48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3590640"/>
            <a:ext cx="1987200" cy="48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8894880"/>
            <a:ext cx="1987200" cy="48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8894880"/>
            <a:ext cx="1987200" cy="48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8894880"/>
            <a:ext cx="1987200" cy="48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24F45C-F9EC-4440-B35A-E5266102F58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615960"/>
            <a:ext cx="6172200" cy="256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3590640"/>
            <a:ext cx="6172200" cy="10155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1DAA67-2FEA-4AB5-9AD3-0419F487FB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615960"/>
            <a:ext cx="6172200" cy="256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3590640"/>
            <a:ext cx="6172200" cy="10155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177A4A-C6E2-497F-80B7-D599F67491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615960"/>
            <a:ext cx="6172200" cy="256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3590640"/>
            <a:ext cx="3011760" cy="10155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3590640"/>
            <a:ext cx="3011760" cy="10155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772F11-B109-4165-A683-68AE9FD8A0A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615960"/>
            <a:ext cx="6172200" cy="256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63822B-052F-4157-AB3D-521AA36492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615960"/>
            <a:ext cx="6172200" cy="11892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3B5B95-7E64-45F1-8A00-4DFFEB749A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615960"/>
            <a:ext cx="6172200" cy="256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3590640"/>
            <a:ext cx="3011760" cy="48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3590640"/>
            <a:ext cx="3011760" cy="10155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8894880"/>
            <a:ext cx="3011760" cy="48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278D7B-ED62-4D74-86FF-5DAEB2DE4A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615960"/>
            <a:ext cx="6172200" cy="256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3590640"/>
            <a:ext cx="3011760" cy="10155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3590640"/>
            <a:ext cx="3011760" cy="48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8894880"/>
            <a:ext cx="3011760" cy="48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AF42A5-1775-4819-9DD1-ACA4FA4257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615960"/>
            <a:ext cx="6172200" cy="256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3590640"/>
            <a:ext cx="3011760" cy="48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3590640"/>
            <a:ext cx="3011760" cy="48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8894880"/>
            <a:ext cx="6172200" cy="4843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897575-85CD-49FE-A11A-4047BF4D9E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615960"/>
            <a:ext cx="6172200" cy="256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3590640"/>
            <a:ext cx="6172200" cy="10155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14013000"/>
            <a:ext cx="1600200" cy="106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14013000"/>
            <a:ext cx="2171520" cy="106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14013000"/>
            <a:ext cx="1600200" cy="1069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64AF11-B2FC-4D1E-99A5-754E7DB7354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638280" y="371520"/>
            <a:ext cx="5619600" cy="7850160"/>
            <a:chOff x="638280" y="371520"/>
            <a:chExt cx="5619600" cy="7850160"/>
          </a:xfrm>
        </p:grpSpPr>
        <p:pic>
          <p:nvPicPr>
            <p:cNvPr id="42" name="" descr=""/>
            <p:cNvPicPr/>
            <p:nvPr/>
          </p:nvPicPr>
          <p:blipFill>
            <a:blip r:embed="rId1"/>
            <a:stretch/>
          </p:blipFill>
          <p:spPr>
            <a:xfrm>
              <a:off x="704880" y="3524400"/>
              <a:ext cx="5553000" cy="1687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" descr=""/>
            <p:cNvPicPr/>
            <p:nvPr/>
          </p:nvPicPr>
          <p:blipFill>
            <a:blip r:embed="rId2"/>
            <a:stretch/>
          </p:blipFill>
          <p:spPr>
            <a:xfrm>
              <a:off x="762120" y="2209680"/>
              <a:ext cx="5370480" cy="12193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4" name=""/>
            <p:cNvGrpSpPr/>
            <p:nvPr/>
          </p:nvGrpSpPr>
          <p:grpSpPr>
            <a:xfrm>
              <a:off x="762120" y="779400"/>
              <a:ext cx="5371920" cy="1354320"/>
              <a:chOff x="762120" y="779400"/>
              <a:chExt cx="5371920" cy="1354320"/>
            </a:xfrm>
          </p:grpSpPr>
          <p:sp>
            <p:nvSpPr>
              <p:cNvPr id="45" name=""/>
              <p:cNvSpPr/>
              <p:nvPr/>
            </p:nvSpPr>
            <p:spPr>
              <a:xfrm>
                <a:off x="771480" y="779400"/>
                <a:ext cx="2666880" cy="357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1     2     3     4     5     6     7     8    9    10   11  1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46" name="" descr=""/>
              <p:cNvPicPr/>
              <p:nvPr/>
            </p:nvPicPr>
            <p:blipFill>
              <a:blip r:embed="rId3">
                <a:lum contrast="48000"/>
              </a:blip>
              <a:stretch/>
            </p:blipFill>
            <p:spPr>
              <a:xfrm>
                <a:off x="3444840" y="1013040"/>
                <a:ext cx="2651040" cy="1077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7" name="" descr=""/>
              <p:cNvPicPr/>
              <p:nvPr/>
            </p:nvPicPr>
            <p:blipFill>
              <a:blip r:embed="rId4"/>
              <a:stretch/>
            </p:blipFill>
            <p:spPr>
              <a:xfrm>
                <a:off x="762120" y="1013040"/>
                <a:ext cx="2651040" cy="1077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8" name=""/>
              <p:cNvSpPr/>
              <p:nvPr/>
            </p:nvSpPr>
            <p:spPr>
              <a:xfrm>
                <a:off x="914400" y="1828800"/>
                <a:ext cx="2286000" cy="30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  </a:t>
                </a:r>
                <a:r>
                  <a:rPr b="0" i="1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Cla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I     </a:t>
                </a:r>
                <a:r>
                  <a:rPr b="0" i="1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Eco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RI    </a:t>
                </a:r>
                <a:r>
                  <a:rPr b="0" i="1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Hin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dIII    </a:t>
                </a:r>
                <a:r>
                  <a:rPr b="0" i="1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Kpn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I      </a:t>
                </a:r>
                <a:r>
                  <a:rPr b="0" i="1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Pst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I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3467160" y="785880"/>
                <a:ext cx="2666880" cy="357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1     2     3    4     5     6     7     8    9    10   11   1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3657600" y="1828800"/>
                <a:ext cx="2286000" cy="30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  </a:t>
                </a:r>
                <a:r>
                  <a:rPr b="0" i="1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Cla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I     </a:t>
                </a:r>
                <a:r>
                  <a:rPr b="0" i="1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Eco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RI   </a:t>
                </a:r>
                <a:r>
                  <a:rPr b="0" i="1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Hin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dIII   </a:t>
                </a:r>
                <a:r>
                  <a:rPr b="0" i="1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Kpn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I      </a:t>
                </a:r>
                <a:r>
                  <a:rPr b="0" i="1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Pst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SimSun"/>
                  </a:rPr>
                  <a:t>I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762120" y="827280"/>
                <a:ext cx="5333760" cy="125712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2" name=""/>
            <p:cNvSpPr/>
            <p:nvPr/>
          </p:nvSpPr>
          <p:spPr>
            <a:xfrm>
              <a:off x="638280" y="371520"/>
              <a:ext cx="1800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Supporting Figure S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676440" y="569880"/>
              <a:ext cx="466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(A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685800" y="2019240"/>
              <a:ext cx="457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(C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685800" y="3352680"/>
              <a:ext cx="457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(D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6" name="" descr=""/>
            <p:cNvPicPr/>
            <p:nvPr/>
          </p:nvPicPr>
          <p:blipFill>
            <a:blip r:embed="rId5"/>
            <a:stretch/>
          </p:blipFill>
          <p:spPr>
            <a:xfrm>
              <a:off x="762120" y="5210280"/>
              <a:ext cx="2895480" cy="1600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7" name=""/>
            <p:cNvSpPr/>
            <p:nvPr/>
          </p:nvSpPr>
          <p:spPr>
            <a:xfrm>
              <a:off x="714240" y="5181480"/>
              <a:ext cx="428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Times New Roman"/>
                </a:rPr>
                <a:t>(E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686040" y="5219640"/>
              <a:ext cx="2497320" cy="159408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9" name=""/>
            <p:cNvGrpSpPr/>
            <p:nvPr/>
          </p:nvGrpSpPr>
          <p:grpSpPr>
            <a:xfrm>
              <a:off x="4267080" y="5448240"/>
              <a:ext cx="1795680" cy="1157040"/>
              <a:chOff x="4267080" y="5448240"/>
              <a:chExt cx="1795680" cy="1157040"/>
            </a:xfrm>
          </p:grpSpPr>
          <p:sp>
            <p:nvSpPr>
              <p:cNvPr id="60" name=""/>
              <p:cNvSpPr/>
              <p:nvPr/>
            </p:nvSpPr>
            <p:spPr>
              <a:xfrm>
                <a:off x="4267080" y="6603840"/>
                <a:ext cx="17956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4267080" y="6461280"/>
                <a:ext cx="17956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4267080" y="6313320"/>
                <a:ext cx="179568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4267080" y="6171120"/>
                <a:ext cx="17956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4267080" y="6027120"/>
                <a:ext cx="17956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4267080" y="5880600"/>
                <a:ext cx="17956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4267080" y="5736960"/>
                <a:ext cx="17956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4267080" y="5590080"/>
                <a:ext cx="17956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4267080" y="5448240"/>
                <a:ext cx="1795680" cy="10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9" name=""/>
            <p:cNvSpPr/>
            <p:nvPr/>
          </p:nvSpPr>
          <p:spPr>
            <a:xfrm>
              <a:off x="4473720" y="5568840"/>
              <a:ext cx="317520" cy="1035000"/>
            </a:xfrm>
            <a:prstGeom prst="rect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5280120" y="5797440"/>
              <a:ext cx="317520" cy="806400"/>
            </a:xfrm>
            <a:prstGeom prst="rect">
              <a:avLst/>
            </a:prstGeom>
            <a:solidFill>
              <a:srgbClr val="339966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4791240" y="5629320"/>
              <a:ext cx="314280" cy="974520"/>
            </a:xfrm>
            <a:prstGeom prst="rect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5597640" y="5838840"/>
              <a:ext cx="314280" cy="765000"/>
            </a:xfrm>
            <a:prstGeom prst="rect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4267080" y="5457960"/>
              <a:ext cx="1800" cy="1155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4496040" y="5962680"/>
              <a:ext cx="28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71.4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5297760" y="6121440"/>
              <a:ext cx="28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55.9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4808520" y="5991120"/>
              <a:ext cx="28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67.5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5605560" y="6143760"/>
              <a:ext cx="28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52.9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8" name=""/>
            <p:cNvGrpSpPr/>
            <p:nvPr/>
          </p:nvGrpSpPr>
          <p:grpSpPr>
            <a:xfrm>
              <a:off x="4114080" y="5353200"/>
              <a:ext cx="128880" cy="1335960"/>
              <a:chOff x="4114080" y="5353200"/>
              <a:chExt cx="128880" cy="1335960"/>
            </a:xfrm>
          </p:grpSpPr>
          <p:sp>
            <p:nvSpPr>
              <p:cNvPr id="79" name=""/>
              <p:cNvSpPr/>
              <p:nvPr/>
            </p:nvSpPr>
            <p:spPr>
              <a:xfrm>
                <a:off x="4137480" y="6536520"/>
                <a:ext cx="648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4114080" y="6389280"/>
                <a:ext cx="12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4114080" y="6239160"/>
                <a:ext cx="12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4114080" y="6092280"/>
                <a:ext cx="12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3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4114080" y="5946840"/>
                <a:ext cx="12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4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4114080" y="5795280"/>
                <a:ext cx="12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4114080" y="5649840"/>
                <a:ext cx="12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6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4114080" y="5498280"/>
                <a:ext cx="12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7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4114080" y="5353200"/>
                <a:ext cx="12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8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8" name=""/>
            <p:cNvSpPr/>
            <p:nvPr/>
          </p:nvSpPr>
          <p:spPr>
            <a:xfrm>
              <a:off x="4532400" y="6624720"/>
              <a:ext cx="1563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WT   Rev3        WT   Rev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rot="16200000">
              <a:off x="3389760" y="5878080"/>
              <a:ext cx="99288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No. of florets/seed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per panicl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0" name=""/>
            <p:cNvGrpSpPr/>
            <p:nvPr/>
          </p:nvGrpSpPr>
          <p:grpSpPr>
            <a:xfrm>
              <a:off x="4608360" y="5524560"/>
              <a:ext cx="63720" cy="46080"/>
              <a:chOff x="4608360" y="5524560"/>
              <a:chExt cx="63720" cy="46080"/>
            </a:xfrm>
          </p:grpSpPr>
          <p:sp>
            <p:nvSpPr>
              <p:cNvPr id="91" name=""/>
              <p:cNvSpPr/>
              <p:nvPr/>
            </p:nvSpPr>
            <p:spPr>
              <a:xfrm flipV="1">
                <a:off x="4635720" y="5524560"/>
                <a:ext cx="1080" cy="46080"/>
              </a:xfrm>
              <a:prstGeom prst="line">
                <a:avLst/>
              </a:prstGeom>
              <a:ln w="9360">
                <a:solidFill>
                  <a:srgbClr val="008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" bIns="-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4608360" y="5524560"/>
                <a:ext cx="63720" cy="1440"/>
              </a:xfrm>
              <a:prstGeom prst="line">
                <a:avLst/>
              </a:prstGeom>
              <a:ln w="9360">
                <a:solidFill>
                  <a:srgbClr val="008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3" name=""/>
            <p:cNvGrpSpPr/>
            <p:nvPr/>
          </p:nvGrpSpPr>
          <p:grpSpPr>
            <a:xfrm>
              <a:off x="4921200" y="5609880"/>
              <a:ext cx="63720" cy="28440"/>
              <a:chOff x="4921200" y="5609880"/>
              <a:chExt cx="63720" cy="28440"/>
            </a:xfrm>
          </p:grpSpPr>
          <p:sp>
            <p:nvSpPr>
              <p:cNvPr id="94" name=""/>
              <p:cNvSpPr/>
              <p:nvPr/>
            </p:nvSpPr>
            <p:spPr>
              <a:xfrm flipV="1">
                <a:off x="4948200" y="5609880"/>
                <a:ext cx="1800" cy="28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4921200" y="5610240"/>
                <a:ext cx="6372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6" name=""/>
            <p:cNvGrpSpPr/>
            <p:nvPr/>
          </p:nvGrpSpPr>
          <p:grpSpPr>
            <a:xfrm>
              <a:off x="5413320" y="5745240"/>
              <a:ext cx="63720" cy="55440"/>
              <a:chOff x="5413320" y="5745240"/>
              <a:chExt cx="63720" cy="55440"/>
            </a:xfrm>
          </p:grpSpPr>
          <p:sp>
            <p:nvSpPr>
              <p:cNvPr id="97" name=""/>
              <p:cNvSpPr/>
              <p:nvPr/>
            </p:nvSpPr>
            <p:spPr>
              <a:xfrm flipV="1">
                <a:off x="5440680" y="5745240"/>
                <a:ext cx="1080" cy="55440"/>
              </a:xfrm>
              <a:prstGeom prst="line">
                <a:avLst/>
              </a:prstGeom>
              <a:ln w="9360">
                <a:solidFill>
                  <a:srgbClr val="008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5413320" y="5745240"/>
                <a:ext cx="63720" cy="1440"/>
              </a:xfrm>
              <a:prstGeom prst="line">
                <a:avLst/>
              </a:prstGeom>
              <a:ln w="9360">
                <a:solidFill>
                  <a:srgbClr val="008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9" name=""/>
            <p:cNvGrpSpPr/>
            <p:nvPr/>
          </p:nvGrpSpPr>
          <p:grpSpPr>
            <a:xfrm>
              <a:off x="5722920" y="5820840"/>
              <a:ext cx="63360" cy="17640"/>
              <a:chOff x="5722920" y="5820840"/>
              <a:chExt cx="63360" cy="17640"/>
            </a:xfrm>
          </p:grpSpPr>
          <p:sp>
            <p:nvSpPr>
              <p:cNvPr id="100" name=""/>
              <p:cNvSpPr/>
              <p:nvPr/>
            </p:nvSpPr>
            <p:spPr>
              <a:xfrm flipV="1">
                <a:off x="5749920" y="5820840"/>
                <a:ext cx="1080" cy="17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5722920" y="5821200"/>
                <a:ext cx="6336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2" name=""/>
            <p:cNvSpPr/>
            <p:nvPr/>
          </p:nvSpPr>
          <p:spPr>
            <a:xfrm>
              <a:off x="3625920" y="5191200"/>
              <a:ext cx="412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(F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3429000" y="569880"/>
              <a:ext cx="457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(B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4" name="" descr=""/>
            <p:cNvPicPr/>
            <p:nvPr/>
          </p:nvPicPr>
          <p:blipFill>
            <a:blip r:embed="rId6"/>
            <a:srcRect l="0" t="0" r="23584" b="0"/>
            <a:stretch/>
          </p:blipFill>
          <p:spPr>
            <a:xfrm>
              <a:off x="770040" y="7004160"/>
              <a:ext cx="2354040" cy="1217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05" name=""/>
            <p:cNvSpPr/>
            <p:nvPr/>
          </p:nvSpPr>
          <p:spPr>
            <a:xfrm>
              <a:off x="704880" y="6962760"/>
              <a:ext cx="2495520" cy="268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5880" rIns="65880" tIns="32760" bIns="32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SimSun"/>
                </a:rPr>
                <a:t>  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  <a:ea typeface="SimSun"/>
                </a:rPr>
                <a:t>C1     C2      C3     C4      C5      C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3147840" y="6997680"/>
              <a:ext cx="2109960" cy="121608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3537000" y="7993080"/>
              <a:ext cx="1673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3537000" y="7815240"/>
              <a:ext cx="1673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3537000" y="7635960"/>
              <a:ext cx="1673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3537000" y="7454880"/>
              <a:ext cx="1673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3537000" y="7277040"/>
              <a:ext cx="16732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3537000" y="7097760"/>
              <a:ext cx="1673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3581280" y="7345440"/>
              <a:ext cx="204840" cy="647640"/>
            </a:xfrm>
            <a:prstGeom prst="rect">
              <a:avLst/>
            </a:prstGeom>
            <a:solidFill>
              <a:srgbClr val="00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3809880" y="7656480"/>
              <a:ext cx="204840" cy="33660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4038480" y="7354800"/>
              <a:ext cx="204840" cy="638280"/>
            </a:xfrm>
            <a:prstGeom prst="rect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4267080" y="7345440"/>
              <a:ext cx="200160" cy="647640"/>
            </a:xfrm>
            <a:prstGeom prst="rect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4495680" y="7408800"/>
              <a:ext cx="204840" cy="584280"/>
            </a:xfrm>
            <a:prstGeom prst="rect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4724280" y="7412040"/>
              <a:ext cx="204840" cy="581040"/>
            </a:xfrm>
            <a:prstGeom prst="rect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 flipV="1">
              <a:off x="3683160" y="7341840"/>
              <a:ext cx="1440" cy="32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3668760" y="7342200"/>
              <a:ext cx="34920" cy="1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 flipV="1">
              <a:off x="3913200" y="7648560"/>
              <a:ext cx="1440" cy="79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3897360" y="7648560"/>
              <a:ext cx="34920" cy="1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 flipV="1">
              <a:off x="4141800" y="7308720"/>
              <a:ext cx="1440" cy="460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4127400" y="7308720"/>
              <a:ext cx="33480" cy="1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 flipV="1">
              <a:off x="4363920" y="7292880"/>
              <a:ext cx="1800" cy="5256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4349880" y="7292880"/>
              <a:ext cx="33120" cy="1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 flipV="1">
              <a:off x="4597560" y="7386480"/>
              <a:ext cx="1440" cy="223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4583160" y="7386480"/>
              <a:ext cx="34920" cy="1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 flipV="1">
              <a:off x="4827600" y="7392600"/>
              <a:ext cx="1440" cy="190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4811760" y="7392960"/>
              <a:ext cx="34920" cy="144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3537000" y="7097760"/>
              <a:ext cx="1440" cy="895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3503520" y="7993080"/>
              <a:ext cx="334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3503520" y="7815240"/>
              <a:ext cx="334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3503520" y="7635960"/>
              <a:ext cx="334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3503520" y="7454880"/>
              <a:ext cx="334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3503520" y="7277040"/>
              <a:ext cx="334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3503520" y="7097760"/>
              <a:ext cx="334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3401280" y="791532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3347280" y="773748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3347280" y="755964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3347280" y="737712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3347280" y="7199280"/>
              <a:ext cx="128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3292920" y="7021440"/>
              <a:ext cx="19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3652920" y="8005680"/>
              <a:ext cx="1604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     2    C1   C2  C3   C5  C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 rot="16200000">
              <a:off x="2790000" y="7460640"/>
              <a:ext cx="884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Plant height (cm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695160" y="6753240"/>
              <a:ext cx="447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(G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3124080" y="6753240"/>
              <a:ext cx="457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(H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8" name=""/>
            <p:cNvGrpSpPr/>
            <p:nvPr/>
          </p:nvGrpSpPr>
          <p:grpSpPr>
            <a:xfrm>
              <a:off x="4952880" y="7338960"/>
              <a:ext cx="195120" cy="657000"/>
              <a:chOff x="4952880" y="7338960"/>
              <a:chExt cx="195120" cy="657000"/>
            </a:xfrm>
          </p:grpSpPr>
          <p:sp>
            <p:nvSpPr>
              <p:cNvPr id="149" name=""/>
              <p:cNvSpPr/>
              <p:nvPr/>
            </p:nvSpPr>
            <p:spPr>
              <a:xfrm>
                <a:off x="4952880" y="7365600"/>
                <a:ext cx="195120" cy="630360"/>
              </a:xfrm>
              <a:prstGeom prst="rect">
                <a:avLst/>
              </a:prstGeom>
              <a:solidFill>
                <a:srgbClr val="000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 flipV="1">
                <a:off x="5051160" y="7338960"/>
                <a:ext cx="1800" cy="2664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160" bIns="-20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5037120" y="7338960"/>
                <a:ext cx="31680" cy="720"/>
              </a:xfrm>
              <a:prstGeom prst="line">
                <a:avLst/>
              </a:prstGeom>
              <a:ln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080" bIns="-46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52" name=""/>
            <p:cNvSpPr/>
            <p:nvPr/>
          </p:nvSpPr>
          <p:spPr>
            <a:xfrm>
              <a:off x="4081320" y="7581960"/>
              <a:ext cx="162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C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4305240" y="7572240"/>
              <a:ext cx="162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C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4533840" y="7581960"/>
              <a:ext cx="162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C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4772160" y="7581960"/>
              <a:ext cx="161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C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4984920" y="7591320"/>
              <a:ext cx="161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</a:rPr>
                <a:t>C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4524480" y="5238720"/>
              <a:ext cx="609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Floret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5362560" y="5533920"/>
              <a:ext cx="609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Seed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5272200" y="7000920"/>
              <a:ext cx="919080" cy="121284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0" name=""/>
            <p:cNvGrpSpPr/>
            <p:nvPr/>
          </p:nvGrpSpPr>
          <p:grpSpPr>
            <a:xfrm>
              <a:off x="5562720" y="7074000"/>
              <a:ext cx="612720" cy="976320"/>
              <a:chOff x="5562720" y="7074000"/>
              <a:chExt cx="612720" cy="976320"/>
            </a:xfrm>
          </p:grpSpPr>
          <p:sp>
            <p:nvSpPr>
              <p:cNvPr id="161" name=""/>
              <p:cNvSpPr/>
              <p:nvPr/>
            </p:nvSpPr>
            <p:spPr>
              <a:xfrm>
                <a:off x="5562720" y="8050320"/>
                <a:ext cx="6127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5562720" y="7886880"/>
                <a:ext cx="6127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5562720" y="7726680"/>
                <a:ext cx="6127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5562720" y="7562880"/>
                <a:ext cx="6127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5562720" y="7399440"/>
                <a:ext cx="6127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5562720" y="7239240"/>
                <a:ext cx="6127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5562720" y="7074000"/>
                <a:ext cx="6127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8" name=""/>
            <p:cNvSpPr/>
            <p:nvPr/>
          </p:nvSpPr>
          <p:spPr>
            <a:xfrm>
              <a:off x="5638680" y="7238880"/>
              <a:ext cx="177840" cy="811440"/>
            </a:xfrm>
            <a:prstGeom prst="rect">
              <a:avLst/>
            </a:prstGeom>
            <a:solidFill>
              <a:srgbClr val="00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5816520" y="8043840"/>
              <a:ext cx="177840" cy="648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0320" bIns="-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5994360" y="7381800"/>
              <a:ext cx="177840" cy="668520"/>
            </a:xfrm>
            <a:prstGeom prst="rect">
              <a:avLst/>
            </a:prstGeom>
            <a:solidFill>
              <a:srgbClr val="000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                                                    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 flipV="1">
              <a:off x="5726160" y="7174080"/>
              <a:ext cx="0" cy="648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5721480" y="7174080"/>
              <a:ext cx="1116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 flipV="1">
              <a:off x="5904000" y="8040240"/>
              <a:ext cx="0" cy="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5899320" y="8040600"/>
              <a:ext cx="1080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 flipV="1">
              <a:off x="6081840" y="7257960"/>
              <a:ext cx="0" cy="1461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6076800" y="7257960"/>
              <a:ext cx="1116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77" name=""/>
            <p:cNvGrpSpPr/>
            <p:nvPr/>
          </p:nvGrpSpPr>
          <p:grpSpPr>
            <a:xfrm>
              <a:off x="5554800" y="7074000"/>
              <a:ext cx="7920" cy="976320"/>
              <a:chOff x="5554800" y="7074000"/>
              <a:chExt cx="7920" cy="976320"/>
            </a:xfrm>
          </p:grpSpPr>
          <p:sp>
            <p:nvSpPr>
              <p:cNvPr id="178" name=""/>
              <p:cNvSpPr/>
              <p:nvPr/>
            </p:nvSpPr>
            <p:spPr>
              <a:xfrm>
                <a:off x="5562720" y="7074000"/>
                <a:ext cx="0" cy="976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5554800" y="8050320"/>
                <a:ext cx="79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5554800" y="7886880"/>
                <a:ext cx="79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5554800" y="7726680"/>
                <a:ext cx="79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5554800" y="7562880"/>
                <a:ext cx="79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5554800" y="7399440"/>
                <a:ext cx="79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5554800" y="7239240"/>
                <a:ext cx="79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5554800" y="7074000"/>
                <a:ext cx="79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86" name=""/>
            <p:cNvGrpSpPr/>
            <p:nvPr/>
          </p:nvGrpSpPr>
          <p:grpSpPr>
            <a:xfrm>
              <a:off x="5394960" y="6996240"/>
              <a:ext cx="160920" cy="1128960"/>
              <a:chOff x="5394960" y="6996240"/>
              <a:chExt cx="160920" cy="1128960"/>
            </a:xfrm>
          </p:grpSpPr>
          <p:sp>
            <p:nvSpPr>
              <p:cNvPr id="187" name=""/>
              <p:cNvSpPr/>
              <p:nvPr/>
            </p:nvSpPr>
            <p:spPr>
              <a:xfrm>
                <a:off x="5412960" y="7972560"/>
                <a:ext cx="648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5394960" y="7813800"/>
                <a:ext cx="16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5394960" y="7647120"/>
                <a:ext cx="16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5394960" y="7483680"/>
                <a:ext cx="16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5394960" y="7320240"/>
                <a:ext cx="16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5412960" y="7159680"/>
                <a:ext cx="648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5394960" y="6996240"/>
                <a:ext cx="16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.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4" name=""/>
            <p:cNvSpPr/>
            <p:nvPr/>
          </p:nvSpPr>
          <p:spPr>
            <a:xfrm>
              <a:off x="5700240" y="8055000"/>
              <a:ext cx="416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   2    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 rot="16200000">
              <a:off x="4783680" y="7535520"/>
              <a:ext cx="10951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</a:rPr>
                <a:t>Relative transcript level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5181480" y="6762600"/>
              <a:ext cx="457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(I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7" name=""/>
          <p:cNvSpPr/>
          <p:nvPr/>
        </p:nvSpPr>
        <p:spPr>
          <a:xfrm>
            <a:off x="685800" y="8215200"/>
            <a:ext cx="5562720" cy="5565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Supporting Figure S2. Genetic, revertant and complementation analyses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(A) and (B) Southern blot hybridization. Genomic DNA samples isolated from WT (Lane 2, 4, 6, 8 and 10)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oscyp96b4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(Lane 3, 5, 7, 9, and 11) were digested with various enzymes as shown above and were hybridized with the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GU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probe (A) and the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OsCYP96B4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probe (B), respectively. Lane 1 and 12 in (A) and (B) are Dig-labeled DNA markers III and VII from Roche, respectively. (C) Co-segregation analysis between the mutant phenotype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D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insertion using a heterozygous F2 population. (D) Sequences showing an 8-bp target duplication (red) after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D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insertion into the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OsCYP96B4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gene in the mutant and footprints with 1- (revertant 1), 8- (revertant 2) and 9- (revertant 3) bp of insertion (compared to WT) after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D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remobilization in revertants. Base substitutions in three independent revertants were shown in blue color. (E) Phenotype of WT (left), revertant 3 (middle) and revertant 1 (right). (F) Detailed investigation of florets and viable seeds in the revertant 3 by compared with WT. (G) The copy number determination of T-DNA insertion in the complementation plants. (H) Phenotype complementation of the semi-dwarf trait in five independent transgenic plants (C1, C2, C3, C5 and C6) with single copy of T-DNA insertion (blue color) by comparing with WT (1, green color) and the mutant plants (2, red color). (I) Expression analysis of transgenic plants by quantitative real-time PCR. 1, expression level in WT plants; 2, expression level in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oscyp96b4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plants; 3, average expression level in complementation plant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13T07:09:36Z</dcterms:created>
  <dc:creator>shuye</dc:creator>
  <dc:description/>
  <dc:language>en-US</dc:language>
  <cp:lastModifiedBy>shuye</cp:lastModifiedBy>
  <dcterms:modified xsi:type="dcterms:W3CDTF">2011-10-17T05:53:37Z</dcterms:modified>
  <cp:revision>26</cp:revision>
  <dc:subject/>
  <dc:title>Slide 1</dc:title>
</cp:coreProperties>
</file>